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40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Rechthoek 7"/>
          <p:cNvSpPr/>
          <p:nvPr userDrawn="1"/>
        </p:nvSpPr>
        <p:spPr>
          <a:xfrm>
            <a:off x="521500" y="594000"/>
            <a:ext cx="8100000" cy="421252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bg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9224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359480" y="6183340"/>
            <a:ext cx="8263020" cy="49935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8" name="Afbeelding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650000" y="5940000"/>
            <a:ext cx="648000" cy="929244"/>
          </a:xfrm>
          <a:prstGeom prst="rect">
            <a:avLst/>
          </a:prstGeom>
        </p:spPr>
      </p:pic>
      <p:sp>
        <p:nvSpPr>
          <p:cNvPr id="3" name="Titel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24155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  <p:sp>
        <p:nvSpPr>
          <p:cNvPr id="9" name="Rechthoek 8"/>
          <p:cNvSpPr/>
          <p:nvPr userDrawn="1"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845441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278196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522000" y="1650209"/>
            <a:ext cx="8100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808550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grafiek wilt toevoegen</a:t>
            </a:r>
            <a:endParaRPr lang="nl-NL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001"/>
            <a:ext cx="4039200" cy="4124912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15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101451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400"/>
            <a:ext cx="4039200" cy="4125600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145721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1652400"/>
            <a:ext cx="81010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47330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smtClean="0"/>
              <a:t>&lt;datum&gt;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 smtClean="0"/>
              <a:t>&lt;Titel van de presentatie&gt;</a:t>
            </a:r>
            <a:endParaRPr lang="nl-NL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592931"/>
            <a:ext cx="8101000" cy="518506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xmlns="" val="369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0"/>
            <a:ext cx="9144000" cy="685799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 smtClean="0"/>
              <a:t>Klik op het pictogram als u een afbeelding wilt toevoegen</a:t>
            </a:r>
            <a:endParaRPr lang="nl-NL" dirty="0"/>
          </a:p>
        </p:txBody>
      </p:sp>
      <p:grpSp>
        <p:nvGrpSpPr>
          <p:cNvPr id="25" name="Groep 24"/>
          <p:cNvGrpSpPr/>
          <p:nvPr userDrawn="1"/>
        </p:nvGrpSpPr>
        <p:grpSpPr>
          <a:xfrm>
            <a:off x="5867400" y="6264275"/>
            <a:ext cx="2427288" cy="301626"/>
            <a:chOff x="5867400" y="6264275"/>
            <a:chExt cx="2427288" cy="301626"/>
          </a:xfrm>
        </p:grpSpPr>
        <p:sp>
          <p:nvSpPr>
            <p:cNvPr id="15" name="Freeform 10"/>
            <p:cNvSpPr>
              <a:spLocks noEditPoints="1"/>
            </p:cNvSpPr>
            <p:nvPr userDrawn="1"/>
          </p:nvSpPr>
          <p:spPr bwMode="auto">
            <a:xfrm>
              <a:off x="5867400" y="6264275"/>
              <a:ext cx="258763" cy="295275"/>
            </a:xfrm>
            <a:custGeom>
              <a:avLst/>
              <a:gdLst>
                <a:gd name="T0" fmla="*/ 389 w 407"/>
                <a:gd name="T1" fmla="*/ 424 h 463"/>
                <a:gd name="T2" fmla="*/ 352 w 407"/>
                <a:gd name="T3" fmla="*/ 397 h 463"/>
                <a:gd name="T4" fmla="*/ 248 w 407"/>
                <a:gd name="T5" fmla="*/ 229 h 463"/>
                <a:gd name="T6" fmla="*/ 346 w 407"/>
                <a:gd name="T7" fmla="*/ 108 h 463"/>
                <a:gd name="T8" fmla="*/ 185 w 407"/>
                <a:gd name="T9" fmla="*/ 0 h 463"/>
                <a:gd name="T10" fmla="*/ 8 w 407"/>
                <a:gd name="T11" fmla="*/ 0 h 463"/>
                <a:gd name="T12" fmla="*/ 0 w 407"/>
                <a:gd name="T13" fmla="*/ 11 h 463"/>
                <a:gd name="T14" fmla="*/ 0 w 407"/>
                <a:gd name="T15" fmla="*/ 24 h 463"/>
                <a:gd name="T16" fmla="*/ 17 w 407"/>
                <a:gd name="T17" fmla="*/ 39 h 463"/>
                <a:gd name="T18" fmla="*/ 46 w 407"/>
                <a:gd name="T19" fmla="*/ 47 h 463"/>
                <a:gd name="T20" fmla="*/ 46 w 407"/>
                <a:gd name="T21" fmla="*/ 417 h 463"/>
                <a:gd name="T22" fmla="*/ 17 w 407"/>
                <a:gd name="T23" fmla="*/ 424 h 463"/>
                <a:gd name="T24" fmla="*/ 0 w 407"/>
                <a:gd name="T25" fmla="*/ 440 h 463"/>
                <a:gd name="T26" fmla="*/ 0 w 407"/>
                <a:gd name="T27" fmla="*/ 453 h 463"/>
                <a:gd name="T28" fmla="*/ 8 w 407"/>
                <a:gd name="T29" fmla="*/ 463 h 463"/>
                <a:gd name="T30" fmla="*/ 167 w 407"/>
                <a:gd name="T31" fmla="*/ 463 h 463"/>
                <a:gd name="T32" fmla="*/ 176 w 407"/>
                <a:gd name="T33" fmla="*/ 453 h 463"/>
                <a:gd name="T34" fmla="*/ 176 w 407"/>
                <a:gd name="T35" fmla="*/ 440 h 463"/>
                <a:gd name="T36" fmla="*/ 158 w 407"/>
                <a:gd name="T37" fmla="*/ 424 h 463"/>
                <a:gd name="T38" fmla="*/ 129 w 407"/>
                <a:gd name="T39" fmla="*/ 417 h 463"/>
                <a:gd name="T40" fmla="*/ 129 w 407"/>
                <a:gd name="T41" fmla="*/ 242 h 463"/>
                <a:gd name="T42" fmla="*/ 171 w 407"/>
                <a:gd name="T43" fmla="*/ 242 h 463"/>
                <a:gd name="T44" fmla="*/ 287 w 407"/>
                <a:gd name="T45" fmla="*/ 452 h 463"/>
                <a:gd name="T46" fmla="*/ 309 w 407"/>
                <a:gd name="T47" fmla="*/ 463 h 463"/>
                <a:gd name="T48" fmla="*/ 398 w 407"/>
                <a:gd name="T49" fmla="*/ 463 h 463"/>
                <a:gd name="T50" fmla="*/ 407 w 407"/>
                <a:gd name="T51" fmla="*/ 453 h 463"/>
                <a:gd name="T52" fmla="*/ 407 w 407"/>
                <a:gd name="T53" fmla="*/ 440 h 463"/>
                <a:gd name="T54" fmla="*/ 389 w 407"/>
                <a:gd name="T55" fmla="*/ 424 h 463"/>
                <a:gd name="T56" fmla="*/ 145 w 407"/>
                <a:gd name="T57" fmla="*/ 203 h 463"/>
                <a:gd name="T58" fmla="*/ 130 w 407"/>
                <a:gd name="T59" fmla="*/ 203 h 463"/>
                <a:gd name="T60" fmla="*/ 130 w 407"/>
                <a:gd name="T61" fmla="*/ 43 h 463"/>
                <a:gd name="T62" fmla="*/ 162 w 407"/>
                <a:gd name="T63" fmla="*/ 43 h 463"/>
                <a:gd name="T64" fmla="*/ 257 w 407"/>
                <a:gd name="T65" fmla="*/ 121 h 463"/>
                <a:gd name="T66" fmla="*/ 145 w 407"/>
                <a:gd name="T67" fmla="*/ 203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6" name="Freeform 11"/>
            <p:cNvSpPr>
              <a:spLocks noEditPoints="1"/>
            </p:cNvSpPr>
            <p:nvPr userDrawn="1"/>
          </p:nvSpPr>
          <p:spPr bwMode="auto">
            <a:xfrm>
              <a:off x="6350000" y="6264275"/>
              <a:ext cx="220663" cy="301625"/>
            </a:xfrm>
            <a:custGeom>
              <a:avLst/>
              <a:gdLst>
                <a:gd name="T0" fmla="*/ 331 w 348"/>
                <a:gd name="T1" fmla="*/ 428 h 473"/>
                <a:gd name="T2" fmla="*/ 299 w 348"/>
                <a:gd name="T3" fmla="*/ 418 h 473"/>
                <a:gd name="T4" fmla="*/ 299 w 348"/>
                <a:gd name="T5" fmla="*/ 16 h 473"/>
                <a:gd name="T6" fmla="*/ 284 w 348"/>
                <a:gd name="T7" fmla="*/ 0 h 473"/>
                <a:gd name="T8" fmla="*/ 186 w 348"/>
                <a:gd name="T9" fmla="*/ 0 h 473"/>
                <a:gd name="T10" fmla="*/ 178 w 348"/>
                <a:gd name="T11" fmla="*/ 11 h 473"/>
                <a:gd name="T12" fmla="*/ 178 w 348"/>
                <a:gd name="T13" fmla="*/ 19 h 473"/>
                <a:gd name="T14" fmla="*/ 196 w 348"/>
                <a:gd name="T15" fmla="*/ 36 h 473"/>
                <a:gd name="T16" fmla="*/ 227 w 348"/>
                <a:gd name="T17" fmla="*/ 45 h 473"/>
                <a:gd name="T18" fmla="*/ 227 w 348"/>
                <a:gd name="T19" fmla="*/ 158 h 473"/>
                <a:gd name="T20" fmla="*/ 153 w 348"/>
                <a:gd name="T21" fmla="*/ 133 h 473"/>
                <a:gd name="T22" fmla="*/ 0 w 348"/>
                <a:gd name="T23" fmla="*/ 313 h 473"/>
                <a:gd name="T24" fmla="*/ 123 w 348"/>
                <a:gd name="T25" fmla="*/ 473 h 473"/>
                <a:gd name="T26" fmla="*/ 227 w 348"/>
                <a:gd name="T27" fmla="*/ 420 h 473"/>
                <a:gd name="T28" fmla="*/ 227 w 348"/>
                <a:gd name="T29" fmla="*/ 447 h 473"/>
                <a:gd name="T30" fmla="*/ 242 w 348"/>
                <a:gd name="T31" fmla="*/ 463 h 473"/>
                <a:gd name="T32" fmla="*/ 340 w 348"/>
                <a:gd name="T33" fmla="*/ 463 h 473"/>
                <a:gd name="T34" fmla="*/ 348 w 348"/>
                <a:gd name="T35" fmla="*/ 453 h 473"/>
                <a:gd name="T36" fmla="*/ 348 w 348"/>
                <a:gd name="T37" fmla="*/ 444 h 473"/>
                <a:gd name="T38" fmla="*/ 331 w 348"/>
                <a:gd name="T39" fmla="*/ 428 h 473"/>
                <a:gd name="T40" fmla="*/ 227 w 348"/>
                <a:gd name="T41" fmla="*/ 379 h 473"/>
                <a:gd name="T42" fmla="*/ 153 w 348"/>
                <a:gd name="T43" fmla="*/ 418 h 473"/>
                <a:gd name="T44" fmla="*/ 77 w 348"/>
                <a:gd name="T45" fmla="*/ 299 h 473"/>
                <a:gd name="T46" fmla="*/ 158 w 348"/>
                <a:gd name="T47" fmla="*/ 179 h 473"/>
                <a:gd name="T48" fmla="*/ 227 w 348"/>
                <a:gd name="T49" fmla="*/ 299 h 473"/>
                <a:gd name="T50" fmla="*/ 227 w 348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7" name="Freeform 12"/>
            <p:cNvSpPr>
              <a:spLocks/>
            </p:cNvSpPr>
            <p:nvPr userDrawn="1"/>
          </p:nvSpPr>
          <p:spPr bwMode="auto">
            <a:xfrm>
              <a:off x="7032625" y="6354763"/>
              <a:ext cx="234950" cy="211138"/>
            </a:xfrm>
            <a:custGeom>
              <a:avLst/>
              <a:gdLst>
                <a:gd name="T0" fmla="*/ 323 w 372"/>
                <a:gd name="T1" fmla="*/ 15 h 330"/>
                <a:gd name="T2" fmla="*/ 308 w 372"/>
                <a:gd name="T3" fmla="*/ 0 h 330"/>
                <a:gd name="T4" fmla="*/ 210 w 372"/>
                <a:gd name="T5" fmla="*/ 0 h 330"/>
                <a:gd name="T6" fmla="*/ 202 w 372"/>
                <a:gd name="T7" fmla="*/ 10 h 330"/>
                <a:gd name="T8" fmla="*/ 202 w 372"/>
                <a:gd name="T9" fmla="*/ 19 h 330"/>
                <a:gd name="T10" fmla="*/ 219 w 372"/>
                <a:gd name="T11" fmla="*/ 35 h 330"/>
                <a:gd name="T12" fmla="*/ 251 w 372"/>
                <a:gd name="T13" fmla="*/ 44 h 330"/>
                <a:gd name="T14" fmla="*/ 251 w 372"/>
                <a:gd name="T15" fmla="*/ 236 h 330"/>
                <a:gd name="T16" fmla="*/ 176 w 372"/>
                <a:gd name="T17" fmla="*/ 275 h 330"/>
                <a:gd name="T18" fmla="*/ 121 w 372"/>
                <a:gd name="T19" fmla="*/ 169 h 330"/>
                <a:gd name="T20" fmla="*/ 121 w 372"/>
                <a:gd name="T21" fmla="*/ 15 h 330"/>
                <a:gd name="T22" fmla="*/ 106 w 372"/>
                <a:gd name="T23" fmla="*/ 0 h 330"/>
                <a:gd name="T24" fmla="*/ 8 w 372"/>
                <a:gd name="T25" fmla="*/ 0 h 330"/>
                <a:gd name="T26" fmla="*/ 0 w 372"/>
                <a:gd name="T27" fmla="*/ 10 h 330"/>
                <a:gd name="T28" fmla="*/ 0 w 372"/>
                <a:gd name="T29" fmla="*/ 19 h 330"/>
                <a:gd name="T30" fmla="*/ 18 w 372"/>
                <a:gd name="T31" fmla="*/ 35 h 330"/>
                <a:gd name="T32" fmla="*/ 49 w 372"/>
                <a:gd name="T33" fmla="*/ 44 h 330"/>
                <a:gd name="T34" fmla="*/ 49 w 372"/>
                <a:gd name="T35" fmla="*/ 207 h 330"/>
                <a:gd name="T36" fmla="*/ 145 w 372"/>
                <a:gd name="T37" fmla="*/ 330 h 330"/>
                <a:gd name="T38" fmla="*/ 251 w 372"/>
                <a:gd name="T39" fmla="*/ 277 h 330"/>
                <a:gd name="T40" fmla="*/ 251 w 372"/>
                <a:gd name="T41" fmla="*/ 304 h 330"/>
                <a:gd name="T42" fmla="*/ 266 w 372"/>
                <a:gd name="T43" fmla="*/ 320 h 330"/>
                <a:gd name="T44" fmla="*/ 364 w 372"/>
                <a:gd name="T45" fmla="*/ 320 h 330"/>
                <a:gd name="T46" fmla="*/ 372 w 372"/>
                <a:gd name="T47" fmla="*/ 310 h 330"/>
                <a:gd name="T48" fmla="*/ 372 w 372"/>
                <a:gd name="T49" fmla="*/ 301 h 330"/>
                <a:gd name="T50" fmla="*/ 354 w 372"/>
                <a:gd name="T51" fmla="*/ 285 h 330"/>
                <a:gd name="T52" fmla="*/ 323 w 372"/>
                <a:gd name="T53" fmla="*/ 275 h 330"/>
                <a:gd name="T54" fmla="*/ 323 w 372"/>
                <a:gd name="T55" fmla="*/ 15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8" name="Freeform 13"/>
            <p:cNvSpPr>
              <a:spLocks noEditPoints="1"/>
            </p:cNvSpPr>
            <p:nvPr userDrawn="1"/>
          </p:nvSpPr>
          <p:spPr bwMode="auto">
            <a:xfrm>
              <a:off x="6140450" y="6348413"/>
              <a:ext cx="195263" cy="217488"/>
            </a:xfrm>
            <a:custGeom>
              <a:avLst/>
              <a:gdLst>
                <a:gd name="T0" fmla="*/ 289 w 307"/>
                <a:gd name="T1" fmla="*/ 295 h 340"/>
                <a:gd name="T2" fmla="*/ 258 w 307"/>
                <a:gd name="T3" fmla="*/ 285 h 340"/>
                <a:gd name="T4" fmla="*/ 258 w 307"/>
                <a:gd name="T5" fmla="*/ 106 h 340"/>
                <a:gd name="T6" fmla="*/ 130 w 307"/>
                <a:gd name="T7" fmla="*/ 0 h 340"/>
                <a:gd name="T8" fmla="*/ 45 w 307"/>
                <a:gd name="T9" fmla="*/ 12 h 340"/>
                <a:gd name="T10" fmla="*/ 22 w 307"/>
                <a:gd name="T11" fmla="*/ 39 h 340"/>
                <a:gd name="T12" fmla="*/ 18 w 307"/>
                <a:gd name="T13" fmla="*/ 74 h 340"/>
                <a:gd name="T14" fmla="*/ 24 w 307"/>
                <a:gd name="T15" fmla="*/ 84 h 340"/>
                <a:gd name="T16" fmla="*/ 43 w 307"/>
                <a:gd name="T17" fmla="*/ 76 h 340"/>
                <a:gd name="T18" fmla="*/ 125 w 307"/>
                <a:gd name="T19" fmla="*/ 54 h 340"/>
                <a:gd name="T20" fmla="*/ 185 w 307"/>
                <a:gd name="T21" fmla="*/ 118 h 340"/>
                <a:gd name="T22" fmla="*/ 185 w 307"/>
                <a:gd name="T23" fmla="*/ 151 h 340"/>
                <a:gd name="T24" fmla="*/ 63 w 307"/>
                <a:gd name="T25" fmla="*/ 176 h 340"/>
                <a:gd name="T26" fmla="*/ 0 w 307"/>
                <a:gd name="T27" fmla="*/ 250 h 340"/>
                <a:gd name="T28" fmla="*/ 83 w 307"/>
                <a:gd name="T29" fmla="*/ 340 h 340"/>
                <a:gd name="T30" fmla="*/ 185 w 307"/>
                <a:gd name="T31" fmla="*/ 290 h 340"/>
                <a:gd name="T32" fmla="*/ 185 w 307"/>
                <a:gd name="T33" fmla="*/ 314 h 340"/>
                <a:gd name="T34" fmla="*/ 200 w 307"/>
                <a:gd name="T35" fmla="*/ 330 h 340"/>
                <a:gd name="T36" fmla="*/ 298 w 307"/>
                <a:gd name="T37" fmla="*/ 330 h 340"/>
                <a:gd name="T38" fmla="*/ 307 w 307"/>
                <a:gd name="T39" fmla="*/ 320 h 340"/>
                <a:gd name="T40" fmla="*/ 307 w 307"/>
                <a:gd name="T41" fmla="*/ 311 h 340"/>
                <a:gd name="T42" fmla="*/ 289 w 307"/>
                <a:gd name="T43" fmla="*/ 295 h 340"/>
                <a:gd name="T44" fmla="*/ 185 w 307"/>
                <a:gd name="T45" fmla="*/ 254 h 340"/>
                <a:gd name="T46" fmla="*/ 116 w 307"/>
                <a:gd name="T47" fmla="*/ 285 h 340"/>
                <a:gd name="T48" fmla="*/ 78 w 307"/>
                <a:gd name="T49" fmla="*/ 244 h 340"/>
                <a:gd name="T50" fmla="*/ 114 w 307"/>
                <a:gd name="T51" fmla="*/ 201 h 340"/>
                <a:gd name="T52" fmla="*/ 185 w 307"/>
                <a:gd name="T53" fmla="*/ 184 h 340"/>
                <a:gd name="T54" fmla="*/ 185 w 307"/>
                <a:gd name="T55" fmla="*/ 25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9" name="Freeform 14"/>
            <p:cNvSpPr>
              <a:spLocks noEditPoints="1"/>
            </p:cNvSpPr>
            <p:nvPr userDrawn="1"/>
          </p:nvSpPr>
          <p:spPr bwMode="auto">
            <a:xfrm>
              <a:off x="6565900" y="6264275"/>
              <a:ext cx="222250" cy="301625"/>
            </a:xfrm>
            <a:custGeom>
              <a:avLst/>
              <a:gdLst>
                <a:gd name="T0" fmla="*/ 226 w 349"/>
                <a:gd name="T1" fmla="*/ 133 h 473"/>
                <a:gd name="T2" fmla="*/ 122 w 349"/>
                <a:gd name="T3" fmla="*/ 185 h 473"/>
                <a:gd name="T4" fmla="*/ 122 w 349"/>
                <a:gd name="T5" fmla="*/ 16 h 473"/>
                <a:gd name="T6" fmla="*/ 107 w 349"/>
                <a:gd name="T7" fmla="*/ 0 h 473"/>
                <a:gd name="T8" fmla="*/ 9 w 349"/>
                <a:gd name="T9" fmla="*/ 0 h 473"/>
                <a:gd name="T10" fmla="*/ 0 w 349"/>
                <a:gd name="T11" fmla="*/ 11 h 473"/>
                <a:gd name="T12" fmla="*/ 0 w 349"/>
                <a:gd name="T13" fmla="*/ 19 h 473"/>
                <a:gd name="T14" fmla="*/ 18 w 349"/>
                <a:gd name="T15" fmla="*/ 36 h 473"/>
                <a:gd name="T16" fmla="*/ 49 w 349"/>
                <a:gd name="T17" fmla="*/ 45 h 473"/>
                <a:gd name="T18" fmla="*/ 49 w 349"/>
                <a:gd name="T19" fmla="*/ 422 h 473"/>
                <a:gd name="T20" fmla="*/ 62 w 349"/>
                <a:gd name="T21" fmla="*/ 445 h 473"/>
                <a:gd name="T22" fmla="*/ 182 w 349"/>
                <a:gd name="T23" fmla="*/ 473 h 473"/>
                <a:gd name="T24" fmla="*/ 349 w 349"/>
                <a:gd name="T25" fmla="*/ 291 h 473"/>
                <a:gd name="T26" fmla="*/ 226 w 349"/>
                <a:gd name="T27" fmla="*/ 133 h 473"/>
                <a:gd name="T28" fmla="*/ 181 w 349"/>
                <a:gd name="T29" fmla="*/ 430 h 473"/>
                <a:gd name="T30" fmla="*/ 122 w 349"/>
                <a:gd name="T31" fmla="*/ 337 h 473"/>
                <a:gd name="T32" fmla="*/ 122 w 349"/>
                <a:gd name="T33" fmla="*/ 227 h 473"/>
                <a:gd name="T34" fmla="*/ 196 w 349"/>
                <a:gd name="T35" fmla="*/ 188 h 473"/>
                <a:gd name="T36" fmla="*/ 271 w 349"/>
                <a:gd name="T37" fmla="*/ 305 h 473"/>
                <a:gd name="T38" fmla="*/ 181 w 349"/>
                <a:gd name="T39" fmla="*/ 43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0" name="Freeform 15"/>
            <p:cNvSpPr>
              <a:spLocks noEditPoints="1"/>
            </p:cNvSpPr>
            <p:nvPr userDrawn="1"/>
          </p:nvSpPr>
          <p:spPr bwMode="auto">
            <a:xfrm>
              <a:off x="7283450" y="6264275"/>
              <a:ext cx="222250" cy="301625"/>
            </a:xfrm>
            <a:custGeom>
              <a:avLst/>
              <a:gdLst>
                <a:gd name="T0" fmla="*/ 331 w 349"/>
                <a:gd name="T1" fmla="*/ 428 h 473"/>
                <a:gd name="T2" fmla="*/ 300 w 349"/>
                <a:gd name="T3" fmla="*/ 418 h 473"/>
                <a:gd name="T4" fmla="*/ 300 w 349"/>
                <a:gd name="T5" fmla="*/ 16 h 473"/>
                <a:gd name="T6" fmla="*/ 285 w 349"/>
                <a:gd name="T7" fmla="*/ 0 h 473"/>
                <a:gd name="T8" fmla="*/ 187 w 349"/>
                <a:gd name="T9" fmla="*/ 0 h 473"/>
                <a:gd name="T10" fmla="*/ 178 w 349"/>
                <a:gd name="T11" fmla="*/ 11 h 473"/>
                <a:gd name="T12" fmla="*/ 178 w 349"/>
                <a:gd name="T13" fmla="*/ 19 h 473"/>
                <a:gd name="T14" fmla="*/ 196 w 349"/>
                <a:gd name="T15" fmla="*/ 36 h 473"/>
                <a:gd name="T16" fmla="*/ 227 w 349"/>
                <a:gd name="T17" fmla="*/ 45 h 473"/>
                <a:gd name="T18" fmla="*/ 227 w 349"/>
                <a:gd name="T19" fmla="*/ 158 h 473"/>
                <a:gd name="T20" fmla="*/ 153 w 349"/>
                <a:gd name="T21" fmla="*/ 133 h 473"/>
                <a:gd name="T22" fmla="*/ 0 w 349"/>
                <a:gd name="T23" fmla="*/ 313 h 473"/>
                <a:gd name="T24" fmla="*/ 123 w 349"/>
                <a:gd name="T25" fmla="*/ 473 h 473"/>
                <a:gd name="T26" fmla="*/ 227 w 349"/>
                <a:gd name="T27" fmla="*/ 420 h 473"/>
                <a:gd name="T28" fmla="*/ 227 w 349"/>
                <a:gd name="T29" fmla="*/ 447 h 473"/>
                <a:gd name="T30" fmla="*/ 242 w 349"/>
                <a:gd name="T31" fmla="*/ 463 h 473"/>
                <a:gd name="T32" fmla="*/ 340 w 349"/>
                <a:gd name="T33" fmla="*/ 463 h 473"/>
                <a:gd name="T34" fmla="*/ 349 w 349"/>
                <a:gd name="T35" fmla="*/ 453 h 473"/>
                <a:gd name="T36" fmla="*/ 349 w 349"/>
                <a:gd name="T37" fmla="*/ 444 h 473"/>
                <a:gd name="T38" fmla="*/ 331 w 349"/>
                <a:gd name="T39" fmla="*/ 428 h 473"/>
                <a:gd name="T40" fmla="*/ 227 w 349"/>
                <a:gd name="T41" fmla="*/ 379 h 473"/>
                <a:gd name="T42" fmla="*/ 153 w 349"/>
                <a:gd name="T43" fmla="*/ 418 h 473"/>
                <a:gd name="T44" fmla="*/ 78 w 349"/>
                <a:gd name="T45" fmla="*/ 299 h 473"/>
                <a:gd name="T46" fmla="*/ 158 w 349"/>
                <a:gd name="T47" fmla="*/ 179 h 473"/>
                <a:gd name="T48" fmla="*/ 227 w 349"/>
                <a:gd name="T49" fmla="*/ 299 h 473"/>
                <a:gd name="T50" fmla="*/ 227 w 349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1" name="Freeform 16"/>
            <p:cNvSpPr>
              <a:spLocks noEditPoints="1"/>
            </p:cNvSpPr>
            <p:nvPr userDrawn="1"/>
          </p:nvSpPr>
          <p:spPr bwMode="auto">
            <a:xfrm>
              <a:off x="6816725" y="6348413"/>
              <a:ext cx="204788" cy="217488"/>
            </a:xfrm>
            <a:custGeom>
              <a:avLst/>
              <a:gdLst>
                <a:gd name="T0" fmla="*/ 168 w 322"/>
                <a:gd name="T1" fmla="*/ 0 h 340"/>
                <a:gd name="T2" fmla="*/ 0 w 322"/>
                <a:gd name="T3" fmla="*/ 178 h 340"/>
                <a:gd name="T4" fmla="*/ 154 w 322"/>
                <a:gd name="T5" fmla="*/ 340 h 340"/>
                <a:gd name="T6" fmla="*/ 322 w 322"/>
                <a:gd name="T7" fmla="*/ 162 h 340"/>
                <a:gd name="T8" fmla="*/ 168 w 322"/>
                <a:gd name="T9" fmla="*/ 0 h 340"/>
                <a:gd name="T10" fmla="*/ 162 w 322"/>
                <a:gd name="T11" fmla="*/ 294 h 340"/>
                <a:gd name="T12" fmla="*/ 76 w 322"/>
                <a:gd name="T13" fmla="*/ 170 h 340"/>
                <a:gd name="T14" fmla="*/ 162 w 322"/>
                <a:gd name="T15" fmla="*/ 46 h 340"/>
                <a:gd name="T16" fmla="*/ 248 w 322"/>
                <a:gd name="T17" fmla="*/ 170 h 340"/>
                <a:gd name="T18" fmla="*/ 162 w 322"/>
                <a:gd name="T19" fmla="*/ 29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2" name="Freeform 17"/>
            <p:cNvSpPr>
              <a:spLocks/>
            </p:cNvSpPr>
            <p:nvPr userDrawn="1"/>
          </p:nvSpPr>
          <p:spPr bwMode="auto">
            <a:xfrm>
              <a:off x="8139113" y="6348413"/>
              <a:ext cx="155575" cy="217488"/>
            </a:xfrm>
            <a:custGeom>
              <a:avLst/>
              <a:gdLst>
                <a:gd name="T0" fmla="*/ 247 w 247"/>
                <a:gd name="T1" fmla="*/ 22 h 340"/>
                <a:gd name="T2" fmla="*/ 238 w 247"/>
                <a:gd name="T3" fmla="*/ 11 h 340"/>
                <a:gd name="T4" fmla="*/ 165 w 247"/>
                <a:gd name="T5" fmla="*/ 0 h 340"/>
                <a:gd name="T6" fmla="*/ 0 w 247"/>
                <a:gd name="T7" fmla="*/ 170 h 340"/>
                <a:gd name="T8" fmla="*/ 165 w 247"/>
                <a:gd name="T9" fmla="*/ 340 h 340"/>
                <a:gd name="T10" fmla="*/ 238 w 247"/>
                <a:gd name="T11" fmla="*/ 329 h 340"/>
                <a:gd name="T12" fmla="*/ 247 w 247"/>
                <a:gd name="T13" fmla="*/ 318 h 340"/>
                <a:gd name="T14" fmla="*/ 247 w 247"/>
                <a:gd name="T15" fmla="*/ 269 h 340"/>
                <a:gd name="T16" fmla="*/ 243 w 247"/>
                <a:gd name="T17" fmla="*/ 262 h 340"/>
                <a:gd name="T18" fmla="*/ 231 w 247"/>
                <a:gd name="T19" fmla="*/ 266 h 340"/>
                <a:gd name="T20" fmla="*/ 169 w 247"/>
                <a:gd name="T21" fmla="*/ 281 h 340"/>
                <a:gd name="T22" fmla="*/ 71 w 247"/>
                <a:gd name="T23" fmla="*/ 170 h 340"/>
                <a:gd name="T24" fmla="*/ 169 w 247"/>
                <a:gd name="T25" fmla="*/ 59 h 340"/>
                <a:gd name="T26" fmla="*/ 231 w 247"/>
                <a:gd name="T27" fmla="*/ 74 h 340"/>
                <a:gd name="T28" fmla="*/ 243 w 247"/>
                <a:gd name="T29" fmla="*/ 78 h 340"/>
                <a:gd name="T30" fmla="*/ 247 w 247"/>
                <a:gd name="T31" fmla="*/ 71 h 340"/>
                <a:gd name="T32" fmla="*/ 247 w 247"/>
                <a:gd name="T33" fmla="*/ 22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3" name="Freeform 18"/>
            <p:cNvSpPr>
              <a:spLocks/>
            </p:cNvSpPr>
            <p:nvPr userDrawn="1"/>
          </p:nvSpPr>
          <p:spPr bwMode="auto">
            <a:xfrm>
              <a:off x="7542213" y="6354763"/>
              <a:ext cx="200025" cy="211138"/>
            </a:xfrm>
            <a:custGeom>
              <a:avLst/>
              <a:gdLst>
                <a:gd name="T0" fmla="*/ 9 w 317"/>
                <a:gd name="T1" fmla="*/ 0 h 330"/>
                <a:gd name="T2" fmla="*/ 0 w 317"/>
                <a:gd name="T3" fmla="*/ 10 h 330"/>
                <a:gd name="T4" fmla="*/ 0 w 317"/>
                <a:gd name="T5" fmla="*/ 19 h 330"/>
                <a:gd name="T6" fmla="*/ 18 w 317"/>
                <a:gd name="T7" fmla="*/ 35 h 330"/>
                <a:gd name="T8" fmla="*/ 49 w 317"/>
                <a:gd name="T9" fmla="*/ 44 h 330"/>
                <a:gd name="T10" fmla="*/ 49 w 317"/>
                <a:gd name="T11" fmla="*/ 193 h 330"/>
                <a:gd name="T12" fmla="*/ 152 w 317"/>
                <a:gd name="T13" fmla="*/ 330 h 330"/>
                <a:gd name="T14" fmla="*/ 247 w 317"/>
                <a:gd name="T15" fmla="*/ 280 h 330"/>
                <a:gd name="T16" fmla="*/ 249 w 317"/>
                <a:gd name="T17" fmla="*/ 280 h 330"/>
                <a:gd name="T18" fmla="*/ 249 w 317"/>
                <a:gd name="T19" fmla="*/ 312 h 330"/>
                <a:gd name="T20" fmla="*/ 257 w 317"/>
                <a:gd name="T21" fmla="*/ 320 h 330"/>
                <a:gd name="T22" fmla="*/ 309 w 317"/>
                <a:gd name="T23" fmla="*/ 320 h 330"/>
                <a:gd name="T24" fmla="*/ 317 w 317"/>
                <a:gd name="T25" fmla="*/ 312 h 330"/>
                <a:gd name="T26" fmla="*/ 317 w 317"/>
                <a:gd name="T27" fmla="*/ 8 h 330"/>
                <a:gd name="T28" fmla="*/ 309 w 317"/>
                <a:gd name="T29" fmla="*/ 0 h 330"/>
                <a:gd name="T30" fmla="*/ 255 w 317"/>
                <a:gd name="T31" fmla="*/ 0 h 330"/>
                <a:gd name="T32" fmla="*/ 247 w 317"/>
                <a:gd name="T33" fmla="*/ 8 h 330"/>
                <a:gd name="T34" fmla="*/ 247 w 317"/>
                <a:gd name="T35" fmla="*/ 226 h 330"/>
                <a:gd name="T36" fmla="*/ 173 w 317"/>
                <a:gd name="T37" fmla="*/ 268 h 330"/>
                <a:gd name="T38" fmla="*/ 119 w 317"/>
                <a:gd name="T39" fmla="*/ 173 h 330"/>
                <a:gd name="T40" fmla="*/ 119 w 317"/>
                <a:gd name="T41" fmla="*/ 8 h 330"/>
                <a:gd name="T42" fmla="*/ 111 w 317"/>
                <a:gd name="T43" fmla="*/ 0 h 330"/>
                <a:gd name="T44" fmla="*/ 9 w 317"/>
                <a:gd name="T4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4" name="Freeform 19"/>
            <p:cNvSpPr>
              <a:spLocks/>
            </p:cNvSpPr>
            <p:nvPr userDrawn="1"/>
          </p:nvSpPr>
          <p:spPr bwMode="auto">
            <a:xfrm>
              <a:off x="7799388" y="6348413"/>
              <a:ext cx="295275" cy="211138"/>
            </a:xfrm>
            <a:custGeom>
              <a:avLst/>
              <a:gdLst>
                <a:gd name="T0" fmla="*/ 0 w 467"/>
                <a:gd name="T1" fmla="*/ 322 h 330"/>
                <a:gd name="T2" fmla="*/ 8 w 467"/>
                <a:gd name="T3" fmla="*/ 330 h 330"/>
                <a:gd name="T4" fmla="*/ 62 w 467"/>
                <a:gd name="T5" fmla="*/ 330 h 330"/>
                <a:gd name="T6" fmla="*/ 70 w 467"/>
                <a:gd name="T7" fmla="*/ 322 h 330"/>
                <a:gd name="T8" fmla="*/ 70 w 467"/>
                <a:gd name="T9" fmla="*/ 104 h 330"/>
                <a:gd name="T10" fmla="*/ 145 w 467"/>
                <a:gd name="T11" fmla="*/ 62 h 330"/>
                <a:gd name="T12" fmla="*/ 198 w 467"/>
                <a:gd name="T13" fmla="*/ 157 h 330"/>
                <a:gd name="T14" fmla="*/ 198 w 467"/>
                <a:gd name="T15" fmla="*/ 322 h 330"/>
                <a:gd name="T16" fmla="*/ 206 w 467"/>
                <a:gd name="T17" fmla="*/ 330 h 330"/>
                <a:gd name="T18" fmla="*/ 261 w 467"/>
                <a:gd name="T19" fmla="*/ 330 h 330"/>
                <a:gd name="T20" fmla="*/ 268 w 467"/>
                <a:gd name="T21" fmla="*/ 322 h 330"/>
                <a:gd name="T22" fmla="*/ 268 w 467"/>
                <a:gd name="T23" fmla="*/ 104 h 330"/>
                <a:gd name="T24" fmla="*/ 343 w 467"/>
                <a:gd name="T25" fmla="*/ 62 h 330"/>
                <a:gd name="T26" fmla="*/ 397 w 467"/>
                <a:gd name="T27" fmla="*/ 157 h 330"/>
                <a:gd name="T28" fmla="*/ 397 w 467"/>
                <a:gd name="T29" fmla="*/ 322 h 330"/>
                <a:gd name="T30" fmla="*/ 405 w 467"/>
                <a:gd name="T31" fmla="*/ 330 h 330"/>
                <a:gd name="T32" fmla="*/ 459 w 467"/>
                <a:gd name="T33" fmla="*/ 330 h 330"/>
                <a:gd name="T34" fmla="*/ 467 w 467"/>
                <a:gd name="T35" fmla="*/ 322 h 330"/>
                <a:gd name="T36" fmla="*/ 467 w 467"/>
                <a:gd name="T37" fmla="*/ 137 h 330"/>
                <a:gd name="T38" fmla="*/ 363 w 467"/>
                <a:gd name="T39" fmla="*/ 0 h 330"/>
                <a:gd name="T40" fmla="*/ 253 w 467"/>
                <a:gd name="T41" fmla="*/ 54 h 330"/>
                <a:gd name="T42" fmla="*/ 165 w 467"/>
                <a:gd name="T43" fmla="*/ 0 h 330"/>
                <a:gd name="T44" fmla="*/ 70 w 467"/>
                <a:gd name="T45" fmla="*/ 50 h 330"/>
                <a:gd name="T46" fmla="*/ 68 w 467"/>
                <a:gd name="T47" fmla="*/ 50 h 330"/>
                <a:gd name="T48" fmla="*/ 68 w 467"/>
                <a:gd name="T49" fmla="*/ 18 h 330"/>
                <a:gd name="T50" fmla="*/ 60 w 467"/>
                <a:gd name="T51" fmla="*/ 10 h 330"/>
                <a:gd name="T52" fmla="*/ 8 w 467"/>
                <a:gd name="T53" fmla="*/ 10 h 330"/>
                <a:gd name="T54" fmla="*/ 0 w 467"/>
                <a:gd name="T55" fmla="*/ 18 h 330"/>
                <a:gd name="T56" fmla="*/ 0 w 467"/>
                <a:gd name="T57" fmla="*/ 322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xmlns="" val="183033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/>
          <a:p>
            <a:r>
              <a:rPr lang="nl-NL" dirty="0" smtClean="0"/>
              <a:t>Klik om de stijl te bewerken</a:t>
            </a:r>
            <a:endParaRPr lang="nl-NL" dirty="0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22000" y="1814635"/>
            <a:ext cx="8100000" cy="4125365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nl-NL" dirty="0" smtClean="0"/>
              <a:t>Klik om de modelstijlen te bewerken</a:t>
            </a:r>
          </a:p>
          <a:p>
            <a:pPr lvl="1"/>
            <a:r>
              <a:rPr lang="nl-NL" dirty="0" smtClean="0"/>
              <a:t>Tweede niveau</a:t>
            </a:r>
          </a:p>
          <a:p>
            <a:pPr lvl="2"/>
            <a:r>
              <a:rPr lang="nl-NL" dirty="0" smtClean="0"/>
              <a:t>Derde niveau</a:t>
            </a:r>
          </a:p>
          <a:p>
            <a:pPr lvl="3"/>
            <a:r>
              <a:rPr lang="nl-NL" dirty="0" smtClean="0"/>
              <a:t>Vierde niveau</a:t>
            </a:r>
          </a:p>
          <a:p>
            <a:pPr lvl="4"/>
            <a:r>
              <a:rPr lang="nl-NL" dirty="0" smtClean="0"/>
              <a:t>Vijfde niveau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6414409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datum&gt;</a:t>
            </a:r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6414409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&lt;Titel van de presentatie&gt;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 smtClean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7" name="Rechthoek 6"/>
          <p:cNvSpPr/>
          <p:nvPr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echthoek 17"/>
          <p:cNvSpPr/>
          <p:nvPr/>
        </p:nvSpPr>
        <p:spPr>
          <a:xfrm>
            <a:off x="522000" y="6264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19" name="Afbeelding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200000" y="6415200"/>
            <a:ext cx="1104790" cy="13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78101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6" r:id="rId2"/>
    <p:sldLayoutId id="2147483650" r:id="rId3"/>
    <p:sldLayoutId id="2147483660" r:id="rId4"/>
    <p:sldLayoutId id="2147483652" r:id="rId5"/>
    <p:sldLayoutId id="2147483661" r:id="rId6"/>
    <p:sldLayoutId id="2147483662" r:id="rId7"/>
    <p:sldLayoutId id="2147483663" r:id="rId8"/>
    <p:sldLayoutId id="2147483664" r:id="rId9"/>
    <p:sldLayoutId id="2147483665" r:id="rId10"/>
  </p:sldLayoutIdLst>
  <p:hf sldNum="0" hdr="0" ftr="0" dt="0"/>
  <p:txStyles>
    <p:titleStyle>
      <a:lvl1pPr algn="l" defTabSz="914400" rtl="0" eaLnBrk="1" latinLnBrk="0" hangingPunct="1">
        <a:lnSpc>
          <a:spcPts val="4200"/>
        </a:lnSpc>
        <a:spcBef>
          <a:spcPct val="0"/>
        </a:spcBef>
        <a:buNone/>
        <a:defRPr sz="40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22263" indent="-322263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325438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69963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293813" indent="-322263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250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Afbeelding 7" descr="Afbeelding1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0"/>
            <a:ext cx="4354657" cy="3113136"/>
          </a:xfrm>
          <a:prstGeom prst="rect">
            <a:avLst/>
          </a:prstGeom>
        </p:spPr>
      </p:pic>
      <p:pic>
        <p:nvPicPr>
          <p:cNvPr id="11" name="Afbeelding 10" descr="Afbeelding3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201944" y="136663"/>
            <a:ext cx="4536504" cy="2910843"/>
          </a:xfrm>
          <a:prstGeom prst="rect">
            <a:avLst/>
          </a:prstGeom>
        </p:spPr>
      </p:pic>
      <p:pic>
        <p:nvPicPr>
          <p:cNvPr id="13" name="Afbeelding 12" descr="Afbeelding4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8984" y="3337886"/>
            <a:ext cx="4286992" cy="3052302"/>
          </a:xfrm>
          <a:prstGeom prst="rect">
            <a:avLst/>
          </a:prstGeom>
        </p:spPr>
      </p:pic>
      <p:pic>
        <p:nvPicPr>
          <p:cNvPr id="15" name="Afbeelding 14" descr="Afbeelding5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139952" y="3367008"/>
            <a:ext cx="4888404" cy="3218288"/>
          </a:xfrm>
          <a:prstGeom prst="rect">
            <a:avLst/>
          </a:prstGeom>
        </p:spPr>
      </p:pic>
      <p:sp>
        <p:nvSpPr>
          <p:cNvPr id="6" name="Tekstvak 5"/>
          <p:cNvSpPr txBox="1"/>
          <p:nvPr/>
        </p:nvSpPr>
        <p:spPr>
          <a:xfrm>
            <a:off x="0" y="0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/>
              <a:t>A</a:t>
            </a:r>
            <a:endParaRPr lang="nl-NL" b="1" dirty="0"/>
          </a:p>
        </p:txBody>
      </p:sp>
      <p:sp>
        <p:nvSpPr>
          <p:cNvPr id="7" name="Tekstvak 6"/>
          <p:cNvSpPr txBox="1"/>
          <p:nvPr/>
        </p:nvSpPr>
        <p:spPr>
          <a:xfrm>
            <a:off x="4211960" y="0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/>
              <a:t>B</a:t>
            </a:r>
            <a:endParaRPr lang="nl-NL" b="1" dirty="0"/>
          </a:p>
        </p:txBody>
      </p:sp>
      <p:sp>
        <p:nvSpPr>
          <p:cNvPr id="9" name="Tekstvak 8"/>
          <p:cNvSpPr txBox="1"/>
          <p:nvPr/>
        </p:nvSpPr>
        <p:spPr>
          <a:xfrm>
            <a:off x="0" y="3150984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/>
              <a:t>C</a:t>
            </a:r>
            <a:endParaRPr lang="nl-NL" b="1" dirty="0"/>
          </a:p>
        </p:txBody>
      </p:sp>
      <p:sp>
        <p:nvSpPr>
          <p:cNvPr id="10" name="Tekstvak 9"/>
          <p:cNvSpPr txBox="1"/>
          <p:nvPr/>
        </p:nvSpPr>
        <p:spPr>
          <a:xfrm>
            <a:off x="4206478" y="3140968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/>
              <a:t>D</a:t>
            </a:r>
            <a:endParaRPr lang="nl-NL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kstvak 5"/>
          <p:cNvSpPr txBox="1"/>
          <p:nvPr/>
        </p:nvSpPr>
        <p:spPr>
          <a:xfrm>
            <a:off x="0" y="0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/>
              <a:t>E</a:t>
            </a:r>
            <a:endParaRPr lang="nl-NL" b="1" dirty="0"/>
          </a:p>
        </p:txBody>
      </p:sp>
      <p:pic>
        <p:nvPicPr>
          <p:cNvPr id="10" name="Afbeelding 9" descr="Afbeelding7.tif"/>
          <p:cNvPicPr>
            <a:picLocks noChangeAspect="1"/>
          </p:cNvPicPr>
          <p:nvPr/>
        </p:nvPicPr>
        <p:blipFill>
          <a:blip r:embed="rId2" cstate="print"/>
          <a:srcRect r="8292"/>
          <a:stretch>
            <a:fillRect/>
          </a:stretch>
        </p:blipFill>
        <p:spPr>
          <a:xfrm>
            <a:off x="4396564" y="92988"/>
            <a:ext cx="4495916" cy="3205179"/>
          </a:xfrm>
          <a:prstGeom prst="rect">
            <a:avLst/>
          </a:prstGeom>
        </p:spPr>
      </p:pic>
      <p:pic>
        <p:nvPicPr>
          <p:cNvPr id="12" name="Afbeelding 11" descr="Afbeelding6.tif"/>
          <p:cNvPicPr>
            <a:picLocks noChangeAspect="1"/>
          </p:cNvPicPr>
          <p:nvPr/>
        </p:nvPicPr>
        <p:blipFill>
          <a:blip r:embed="rId3" cstate="print"/>
          <a:srcRect r="6632"/>
          <a:stretch>
            <a:fillRect/>
          </a:stretch>
        </p:blipFill>
        <p:spPr>
          <a:xfrm>
            <a:off x="40030" y="152162"/>
            <a:ext cx="4427984" cy="3100635"/>
          </a:xfrm>
          <a:prstGeom prst="rect">
            <a:avLst/>
          </a:prstGeom>
        </p:spPr>
      </p:pic>
      <p:sp>
        <p:nvSpPr>
          <p:cNvPr id="13" name="Tekstvak 12"/>
          <p:cNvSpPr txBox="1"/>
          <p:nvPr/>
        </p:nvSpPr>
        <p:spPr>
          <a:xfrm>
            <a:off x="4355976" y="0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/>
              <a:t>F</a:t>
            </a:r>
            <a:endParaRPr lang="nl-NL" b="1" dirty="0"/>
          </a:p>
        </p:txBody>
      </p:sp>
      <p:sp>
        <p:nvSpPr>
          <p:cNvPr id="16" name="Tekstvak 15"/>
          <p:cNvSpPr txBox="1"/>
          <p:nvPr/>
        </p:nvSpPr>
        <p:spPr>
          <a:xfrm>
            <a:off x="0" y="3140968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smtClean="0"/>
              <a:t>G</a:t>
            </a:r>
            <a:endParaRPr lang="nl-NL" b="1" dirty="0"/>
          </a:p>
        </p:txBody>
      </p:sp>
      <p:sp>
        <p:nvSpPr>
          <p:cNvPr id="17" name="Tekstvak 16"/>
          <p:cNvSpPr txBox="1"/>
          <p:nvPr/>
        </p:nvSpPr>
        <p:spPr>
          <a:xfrm>
            <a:off x="4397936" y="3249454"/>
            <a:ext cx="4485476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Supplemental figure 1.  Correlation between NGMS QTOF intensity and quantitative concentration. </a:t>
            </a:r>
            <a:r>
              <a:rPr lang="en-US" dirty="0" smtClean="0"/>
              <a:t>For a selection of different classes of IEM-panel metabolites, correlation between NGMS intensity (in relative units) and quantitative concentration was evaluated. Only for free carnitine, correlation was poor with an R</a:t>
            </a:r>
            <a:r>
              <a:rPr lang="en-US" baseline="30000" dirty="0" smtClean="0"/>
              <a:t>2</a:t>
            </a:r>
            <a:r>
              <a:rPr lang="en-US" dirty="0" smtClean="0"/>
              <a:t> of 0,5651 (panel A).  For phenylalanine (B), </a:t>
            </a:r>
            <a:r>
              <a:rPr lang="en-US" dirty="0" err="1" smtClean="0"/>
              <a:t>octanoyl</a:t>
            </a:r>
            <a:r>
              <a:rPr lang="en-US" dirty="0" smtClean="0"/>
              <a:t>-carnitine (C),  3-hydroxyisovaleric-carnitine (D), </a:t>
            </a:r>
            <a:r>
              <a:rPr lang="en-US" dirty="0" err="1" smtClean="0"/>
              <a:t>tetradecenoyl</a:t>
            </a:r>
            <a:r>
              <a:rPr lang="en-US" dirty="0" smtClean="0"/>
              <a:t>-carnitine (E), lysine (F) and tyrosine (G), R</a:t>
            </a:r>
            <a:r>
              <a:rPr lang="en-US" baseline="30000" dirty="0" smtClean="0"/>
              <a:t>2</a:t>
            </a:r>
            <a:r>
              <a:rPr lang="en-US" dirty="0" smtClean="0"/>
              <a:t> was ≥0.9. </a:t>
            </a:r>
            <a:endParaRPr lang="en-US" dirty="0"/>
          </a:p>
        </p:txBody>
      </p:sp>
      <p:pic>
        <p:nvPicPr>
          <p:cNvPr id="19" name="Afbeelding 18" descr="Afbeelding8.tif"/>
          <p:cNvPicPr>
            <a:picLocks noChangeAspect="1"/>
          </p:cNvPicPr>
          <p:nvPr/>
        </p:nvPicPr>
        <p:blipFill>
          <a:blip r:embed="rId4" cstate="print"/>
          <a:srcRect r="4652"/>
          <a:stretch>
            <a:fillRect/>
          </a:stretch>
        </p:blipFill>
        <p:spPr>
          <a:xfrm>
            <a:off x="0" y="3356993"/>
            <a:ext cx="4427984" cy="3036233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63</TotalTime>
  <Words>93</Words>
  <Application>Microsoft Office PowerPoint</Application>
  <PresentationFormat>Diavoorstelling (4:3)</PresentationFormat>
  <Paragraphs>8</Paragraphs>
  <Slides>2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2</vt:i4>
      </vt:variant>
    </vt:vector>
  </HeadingPairs>
  <TitlesOfParts>
    <vt:vector size="3" baseType="lpstr">
      <vt:lpstr>Default Theme</vt:lpstr>
      <vt:lpstr>Dia 1</vt:lpstr>
      <vt:lpstr>Dia 2</vt:lpstr>
    </vt:vector>
  </TitlesOfParts>
  <Company>UMC St Radbou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Coene</dc:creator>
  <cp:lastModifiedBy>Coene</cp:lastModifiedBy>
  <cp:revision>9</cp:revision>
  <dcterms:created xsi:type="dcterms:W3CDTF">2017-11-03T13:19:56Z</dcterms:created>
  <dcterms:modified xsi:type="dcterms:W3CDTF">2017-11-04T19:50:46Z</dcterms:modified>
</cp:coreProperties>
</file>